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8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256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651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6307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0324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9718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3669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6064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3032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010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776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89882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5E9D8-3EB1-4AD9-8FBE-BCA8295AE6E3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74792-0740-4875-91E4-B3EB82A3247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5717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26" Type="http://schemas.openxmlformats.org/officeDocument/2006/relationships/image" Target="../media/image24.tiff"/><Relationship Id="rId3" Type="http://schemas.openxmlformats.org/officeDocument/2006/relationships/image" Target="../media/image2.tiff"/><Relationship Id="rId21" Type="http://schemas.openxmlformats.org/officeDocument/2006/relationships/image" Target="../media/image19.tiff"/><Relationship Id="rId7" Type="http://schemas.openxmlformats.org/officeDocument/2006/relationships/image" Target="../media/image6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5" Type="http://schemas.openxmlformats.org/officeDocument/2006/relationships/image" Target="../media/image23.tiff"/><Relationship Id="rId2" Type="http://schemas.openxmlformats.org/officeDocument/2006/relationships/image" Target="../media/image1.tiff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9.tiff"/><Relationship Id="rId24" Type="http://schemas.openxmlformats.org/officeDocument/2006/relationships/image" Target="../media/image22.tiff"/><Relationship Id="rId5" Type="http://schemas.openxmlformats.org/officeDocument/2006/relationships/image" Target="../media/image4.tiff"/><Relationship Id="rId15" Type="http://schemas.openxmlformats.org/officeDocument/2006/relationships/image" Target="../media/image13.tiff"/><Relationship Id="rId23" Type="http://schemas.openxmlformats.org/officeDocument/2006/relationships/image" Target="../media/image21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4" Type="http://schemas.openxmlformats.org/officeDocument/2006/relationships/image" Target="../media/image3.tiff"/><Relationship Id="rId9" Type="http://schemas.openxmlformats.org/officeDocument/2006/relationships/image" Target="file:///F:\Dropbox\Dropbox\Asynchronous%20rep%20manuscript\Manuscript%20Version%20Oct%202018\Taylor%20et%20al\600ppi\S2-5.tif" TargetMode="External"/><Relationship Id="rId14" Type="http://schemas.openxmlformats.org/officeDocument/2006/relationships/image" Target="../media/image12.tiff"/><Relationship Id="rId22" Type="http://schemas.openxmlformats.org/officeDocument/2006/relationships/image" Target="../media/image20.tiff"/><Relationship Id="rId27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5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3426" y="5532759"/>
            <a:ext cx="1995948" cy="1175099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1068" y="4304578"/>
            <a:ext cx="1998118" cy="1176376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6100" y="3083129"/>
            <a:ext cx="1993749" cy="1173804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7760" y="631689"/>
            <a:ext cx="1990084" cy="1179648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3409" y="1853763"/>
            <a:ext cx="1993253" cy="1181526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7353" y="675139"/>
            <a:ext cx="1932429" cy="923361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 r:link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098" y="4641716"/>
            <a:ext cx="1904090" cy="927928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098" y="3639132"/>
            <a:ext cx="1900616" cy="920682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766" y="2646182"/>
            <a:ext cx="1909948" cy="912619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766" y="1662102"/>
            <a:ext cx="1909948" cy="91261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766" y="664994"/>
            <a:ext cx="1909948" cy="921336"/>
          </a:xfrm>
          <a:prstGeom prst="rect">
            <a:avLst/>
          </a:prstGeom>
        </p:spPr>
      </p:pic>
      <p:cxnSp>
        <p:nvCxnSpPr>
          <p:cNvPr id="9" name="Straight Connector 8"/>
          <p:cNvCxnSpPr/>
          <p:nvPr/>
        </p:nvCxnSpPr>
        <p:spPr>
          <a:xfrm>
            <a:off x="716735" y="1465030"/>
            <a:ext cx="37322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682523" y="2457185"/>
            <a:ext cx="37322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66972" y="3464891"/>
            <a:ext cx="37322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869135" y="1617430"/>
            <a:ext cx="37322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722955" y="4457047"/>
            <a:ext cx="37322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722955" y="5427430"/>
            <a:ext cx="37322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869135" y="215568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ECUM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2258509" y="3937283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 rot="16200000">
            <a:off x="139367" y="985840"/>
            <a:ext cx="5517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200" dirty="0"/>
          </a:p>
        </p:txBody>
      </p:sp>
      <p:sp>
        <p:nvSpPr>
          <p:cNvPr id="8" name="Rectangle 7"/>
          <p:cNvSpPr/>
          <p:nvPr/>
        </p:nvSpPr>
        <p:spPr>
          <a:xfrm rot="16200000">
            <a:off x="62423" y="1982544"/>
            <a:ext cx="705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eon</a:t>
            </a:r>
          </a:p>
        </p:txBody>
      </p:sp>
      <p:sp>
        <p:nvSpPr>
          <p:cNvPr id="17" name="Rectangle 16"/>
          <p:cNvSpPr/>
          <p:nvPr/>
        </p:nvSpPr>
        <p:spPr>
          <a:xfrm rot="16200000">
            <a:off x="66430" y="2872999"/>
            <a:ext cx="6976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dirty="0"/>
          </a:p>
        </p:txBody>
      </p:sp>
      <p:sp>
        <p:nvSpPr>
          <p:cNvPr id="18" name="Rectangle 17"/>
          <p:cNvSpPr/>
          <p:nvPr/>
        </p:nvSpPr>
        <p:spPr>
          <a:xfrm rot="16200000">
            <a:off x="92880" y="5058221"/>
            <a:ext cx="6447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3269709" y="222444"/>
            <a:ext cx="1059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CTUM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7352" y="1657166"/>
            <a:ext cx="1959684" cy="91846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3750" y="2643546"/>
            <a:ext cx="1967782" cy="922255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0827" y="3640402"/>
            <a:ext cx="1982256" cy="91159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2756" y="4646771"/>
            <a:ext cx="1977462" cy="921447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5923781" y="249510"/>
            <a:ext cx="8883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>
            <a:off x="6983643" y="1746250"/>
            <a:ext cx="32190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6983643" y="2955925"/>
            <a:ext cx="32190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6983643" y="4155835"/>
            <a:ext cx="32190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6983643" y="5384800"/>
            <a:ext cx="32190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6983643" y="6584950"/>
            <a:ext cx="32190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 rot="16200000">
            <a:off x="2535161" y="992839"/>
            <a:ext cx="5517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200" dirty="0"/>
          </a:p>
        </p:txBody>
      </p:sp>
      <p:sp>
        <p:nvSpPr>
          <p:cNvPr id="56" name="Rectangle 55"/>
          <p:cNvSpPr/>
          <p:nvPr/>
        </p:nvSpPr>
        <p:spPr>
          <a:xfrm rot="16200000">
            <a:off x="4971640" y="1023299"/>
            <a:ext cx="5517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200" dirty="0"/>
          </a:p>
        </p:txBody>
      </p:sp>
      <p:sp>
        <p:nvSpPr>
          <p:cNvPr id="57" name="Rectangle 56"/>
          <p:cNvSpPr/>
          <p:nvPr/>
        </p:nvSpPr>
        <p:spPr>
          <a:xfrm rot="16200000">
            <a:off x="2458218" y="1989545"/>
            <a:ext cx="705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eon</a:t>
            </a:r>
          </a:p>
        </p:txBody>
      </p:sp>
      <p:sp>
        <p:nvSpPr>
          <p:cNvPr id="58" name="Rectangle 57"/>
          <p:cNvSpPr/>
          <p:nvPr/>
        </p:nvSpPr>
        <p:spPr>
          <a:xfrm rot="16200000">
            <a:off x="4894696" y="2306027"/>
            <a:ext cx="705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eon</a:t>
            </a:r>
          </a:p>
        </p:txBody>
      </p:sp>
      <p:sp>
        <p:nvSpPr>
          <p:cNvPr id="59" name="Rectangle 58"/>
          <p:cNvSpPr/>
          <p:nvPr/>
        </p:nvSpPr>
        <p:spPr>
          <a:xfrm rot="16200000">
            <a:off x="2469623" y="2879999"/>
            <a:ext cx="6976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dirty="0"/>
          </a:p>
        </p:txBody>
      </p:sp>
      <p:sp>
        <p:nvSpPr>
          <p:cNvPr id="60" name="Rectangle 59"/>
          <p:cNvSpPr/>
          <p:nvPr/>
        </p:nvSpPr>
        <p:spPr>
          <a:xfrm rot="16200000">
            <a:off x="4898703" y="3550581"/>
            <a:ext cx="6976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4693519" y="4807506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-138754" y="3995111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/>
          <p:cNvSpPr/>
          <p:nvPr/>
        </p:nvSpPr>
        <p:spPr>
          <a:xfrm rot="16200000">
            <a:off x="2497820" y="5024321"/>
            <a:ext cx="6447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1200" dirty="0"/>
          </a:p>
        </p:txBody>
      </p:sp>
      <p:sp>
        <p:nvSpPr>
          <p:cNvPr id="64" name="Rectangle 63"/>
          <p:cNvSpPr/>
          <p:nvPr/>
        </p:nvSpPr>
        <p:spPr>
          <a:xfrm rot="16200000">
            <a:off x="4925152" y="5905307"/>
            <a:ext cx="6447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1200" dirty="0"/>
          </a:p>
        </p:txBody>
      </p:sp>
      <p:pic>
        <p:nvPicPr>
          <p:cNvPr id="75" name="Picture 74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2288" y="623715"/>
            <a:ext cx="1622395" cy="1167805"/>
          </a:xfrm>
          <a:prstGeom prst="rect">
            <a:avLst/>
          </a:prstGeom>
        </p:spPr>
      </p:pic>
      <p:pic>
        <p:nvPicPr>
          <p:cNvPr id="76" name="Picture 75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2288" y="1849802"/>
            <a:ext cx="1622395" cy="1157551"/>
          </a:xfrm>
          <a:prstGeom prst="rect">
            <a:avLst/>
          </a:prstGeom>
        </p:spPr>
      </p:pic>
      <p:pic>
        <p:nvPicPr>
          <p:cNvPr id="77" name="Picture 76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2288" y="3065415"/>
            <a:ext cx="1622395" cy="1159662"/>
          </a:xfrm>
          <a:prstGeom prst="rect">
            <a:avLst/>
          </a:prstGeom>
        </p:spPr>
      </p:pic>
      <p:pic>
        <p:nvPicPr>
          <p:cNvPr id="78" name="Picture 77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8443" y="4286419"/>
            <a:ext cx="1626240" cy="1152204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5430" y="5492030"/>
            <a:ext cx="1641248" cy="1205025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>
            <a:off x="8164517" y="241536"/>
            <a:ext cx="10021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/>
          <p:cNvSpPr/>
          <p:nvPr/>
        </p:nvSpPr>
        <p:spPr>
          <a:xfrm rot="16200000">
            <a:off x="7428560" y="1013431"/>
            <a:ext cx="5517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200" dirty="0"/>
          </a:p>
        </p:txBody>
      </p:sp>
      <p:sp>
        <p:nvSpPr>
          <p:cNvPr id="82" name="Rectangle 81"/>
          <p:cNvSpPr/>
          <p:nvPr/>
        </p:nvSpPr>
        <p:spPr>
          <a:xfrm rot="16200000">
            <a:off x="7351616" y="2296159"/>
            <a:ext cx="705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eon</a:t>
            </a:r>
          </a:p>
        </p:txBody>
      </p:sp>
      <p:sp>
        <p:nvSpPr>
          <p:cNvPr id="83" name="Rectangle 82"/>
          <p:cNvSpPr/>
          <p:nvPr/>
        </p:nvSpPr>
        <p:spPr>
          <a:xfrm rot="16200000">
            <a:off x="7355623" y="3540713"/>
            <a:ext cx="6976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dirty="0"/>
          </a:p>
        </p:txBody>
      </p:sp>
      <p:sp>
        <p:nvSpPr>
          <p:cNvPr id="84" name="TextBox 83"/>
          <p:cNvSpPr txBox="1"/>
          <p:nvPr/>
        </p:nvSpPr>
        <p:spPr>
          <a:xfrm rot="16200000">
            <a:off x="7150439" y="4797638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Rectangle 84"/>
          <p:cNvSpPr/>
          <p:nvPr/>
        </p:nvSpPr>
        <p:spPr>
          <a:xfrm rot="16200000">
            <a:off x="7382072" y="5895439"/>
            <a:ext cx="6447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1200" dirty="0"/>
          </a:p>
        </p:txBody>
      </p:sp>
      <p:cxnSp>
        <p:nvCxnSpPr>
          <p:cNvPr id="87" name="Straight Connector 86"/>
          <p:cNvCxnSpPr/>
          <p:nvPr/>
        </p:nvCxnSpPr>
        <p:spPr>
          <a:xfrm>
            <a:off x="9166714" y="1700352"/>
            <a:ext cx="31238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9166713" y="2902884"/>
            <a:ext cx="31238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9166713" y="4125683"/>
            <a:ext cx="31238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9166712" y="5352027"/>
            <a:ext cx="31238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9166711" y="6599802"/>
            <a:ext cx="31238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4490291" y="1518929"/>
            <a:ext cx="3499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4490291" y="2464061"/>
            <a:ext cx="3499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4490291" y="3471767"/>
            <a:ext cx="3499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4550796" y="4447302"/>
            <a:ext cx="3499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4550796" y="5462448"/>
            <a:ext cx="3499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10567944" y="249428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9" name="Picture 108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24264" y="623175"/>
            <a:ext cx="1724836" cy="974413"/>
          </a:xfrm>
          <a:prstGeom prst="rect">
            <a:avLst/>
          </a:prstGeom>
        </p:spPr>
      </p:pic>
      <p:pic>
        <p:nvPicPr>
          <p:cNvPr id="110" name="Picture 109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24264" y="1650833"/>
            <a:ext cx="1724836" cy="985783"/>
          </a:xfrm>
          <a:prstGeom prst="rect">
            <a:avLst/>
          </a:prstGeom>
        </p:spPr>
      </p:pic>
      <p:pic>
        <p:nvPicPr>
          <p:cNvPr id="111" name="Picture 110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19768" y="2692218"/>
            <a:ext cx="1728437" cy="976447"/>
          </a:xfrm>
          <a:prstGeom prst="rect">
            <a:avLst/>
          </a:prstGeom>
        </p:spPr>
      </p:pic>
      <p:pic>
        <p:nvPicPr>
          <p:cNvPr id="112" name="Picture 111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22955" y="3728180"/>
            <a:ext cx="1726145" cy="986531"/>
          </a:xfrm>
          <a:prstGeom prst="rect">
            <a:avLst/>
          </a:prstGeom>
        </p:spPr>
      </p:pic>
      <p:pic>
        <p:nvPicPr>
          <p:cNvPr id="113" name="Picture 112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06461" y="4773633"/>
            <a:ext cx="1735257" cy="991739"/>
          </a:xfrm>
          <a:prstGeom prst="rect">
            <a:avLst/>
          </a:prstGeom>
        </p:spPr>
      </p:pic>
      <p:sp>
        <p:nvSpPr>
          <p:cNvPr id="114" name="TextBox 113"/>
          <p:cNvSpPr txBox="1"/>
          <p:nvPr/>
        </p:nvSpPr>
        <p:spPr>
          <a:xfrm rot="16200000">
            <a:off x="9306948" y="4088390"/>
            <a:ext cx="1107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114"/>
          <p:cNvSpPr/>
          <p:nvPr/>
        </p:nvSpPr>
        <p:spPr>
          <a:xfrm rot="16200000">
            <a:off x="9583600" y="924871"/>
            <a:ext cx="5517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200" dirty="0"/>
          </a:p>
        </p:txBody>
      </p:sp>
      <p:sp>
        <p:nvSpPr>
          <p:cNvPr id="116" name="Rectangle 115"/>
          <p:cNvSpPr/>
          <p:nvPr/>
        </p:nvSpPr>
        <p:spPr>
          <a:xfrm rot="16200000">
            <a:off x="9506657" y="2016827"/>
            <a:ext cx="705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Neon</a:t>
            </a:r>
          </a:p>
        </p:txBody>
      </p:sp>
      <p:sp>
        <p:nvSpPr>
          <p:cNvPr id="117" name="Rectangle 116"/>
          <p:cNvSpPr/>
          <p:nvPr/>
        </p:nvSpPr>
        <p:spPr>
          <a:xfrm rot="16200000">
            <a:off x="9518062" y="3069206"/>
            <a:ext cx="6976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en-GB" sz="1200" dirty="0"/>
          </a:p>
        </p:txBody>
      </p:sp>
      <p:sp>
        <p:nvSpPr>
          <p:cNvPr id="118" name="Rectangle 117"/>
          <p:cNvSpPr/>
          <p:nvPr/>
        </p:nvSpPr>
        <p:spPr>
          <a:xfrm rot="16200000">
            <a:off x="9546259" y="5099228"/>
            <a:ext cx="6447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1200" dirty="0"/>
          </a:p>
        </p:txBody>
      </p:sp>
      <p:cxnSp>
        <p:nvCxnSpPr>
          <p:cNvPr id="121" name="Straight Connector 120"/>
          <p:cNvCxnSpPr/>
          <p:nvPr/>
        </p:nvCxnSpPr>
        <p:spPr>
          <a:xfrm>
            <a:off x="11549955" y="5675175"/>
            <a:ext cx="239613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11549955" y="4629781"/>
            <a:ext cx="239613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>
            <a:off x="11549955" y="3579612"/>
            <a:ext cx="239613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11569005" y="2548568"/>
            <a:ext cx="239613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11569005" y="1531466"/>
            <a:ext cx="239613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0311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7</TotalTime>
  <Words>35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Taylor</dc:creator>
  <cp:lastModifiedBy>Martin Taylor</cp:lastModifiedBy>
  <cp:revision>26</cp:revision>
  <cp:lastPrinted>2019-06-10T13:02:46Z</cp:lastPrinted>
  <dcterms:created xsi:type="dcterms:W3CDTF">2019-01-07T16:11:09Z</dcterms:created>
  <dcterms:modified xsi:type="dcterms:W3CDTF">2019-06-10T13:11:55Z</dcterms:modified>
</cp:coreProperties>
</file>